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8" r:id="rId3"/>
    <p:sldId id="257" r:id="rId4"/>
    <p:sldId id="259" r:id="rId5"/>
    <p:sldId id="260" r:id="rId6"/>
    <p:sldId id="261" r:id="rId7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107" d="100"/>
          <a:sy n="107" d="100"/>
        </p:scale>
        <p:origin x="750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宏矩 北島" userId="030d870b973acc8b" providerId="LiveId" clId="{E7CC9A60-A8ED-4DDA-80F5-5F3EEAC3FE68}"/>
    <pc:docChg chg="undo custSel modSld">
      <pc:chgData name="宏矩 北島" userId="030d870b973acc8b" providerId="LiveId" clId="{E7CC9A60-A8ED-4DDA-80F5-5F3EEAC3FE68}" dt="2024-11-19T09:02:20.470" v="56" actId="1076"/>
      <pc:docMkLst>
        <pc:docMk/>
      </pc:docMkLst>
      <pc:sldChg chg="modSp mod">
        <pc:chgData name="宏矩 北島" userId="030d870b973acc8b" providerId="LiveId" clId="{E7CC9A60-A8ED-4DDA-80F5-5F3EEAC3FE68}" dt="2024-11-19T09:02:20.470" v="56" actId="1076"/>
        <pc:sldMkLst>
          <pc:docMk/>
          <pc:sldMk cId="2169076646" sldId="256"/>
        </pc:sldMkLst>
        <pc:spChg chg="mod">
          <ac:chgData name="宏矩 北島" userId="030d870b973acc8b" providerId="LiveId" clId="{E7CC9A60-A8ED-4DDA-80F5-5F3EEAC3FE68}" dt="2024-11-19T09:02:20.470" v="56" actId="1076"/>
          <ac:spMkLst>
            <pc:docMk/>
            <pc:sldMk cId="2169076646" sldId="256"/>
            <ac:spMk id="6" creationId="{B1770FD2-2FAC-6946-211B-F10CA6C86338}"/>
          </ac:spMkLst>
        </pc:spChg>
      </pc:sldChg>
      <pc:sldChg chg="modSp mod">
        <pc:chgData name="宏矩 北島" userId="030d870b973acc8b" providerId="LiveId" clId="{E7CC9A60-A8ED-4DDA-80F5-5F3EEAC3FE68}" dt="2024-11-18T07:51:45.960" v="2" actId="114"/>
        <pc:sldMkLst>
          <pc:docMk/>
          <pc:sldMk cId="2197144160" sldId="257"/>
        </pc:sldMkLst>
        <pc:spChg chg="mod">
          <ac:chgData name="宏矩 北島" userId="030d870b973acc8b" providerId="LiveId" clId="{E7CC9A60-A8ED-4DDA-80F5-5F3EEAC3FE68}" dt="2024-11-18T07:51:45.960" v="2" actId="114"/>
          <ac:spMkLst>
            <pc:docMk/>
            <pc:sldMk cId="2197144160" sldId="257"/>
            <ac:spMk id="6" creationId="{AECC1755-FDB8-C2D5-8CAB-362C44245C53}"/>
          </ac:spMkLst>
        </pc:spChg>
      </pc:sldChg>
      <pc:sldChg chg="modSp mod">
        <pc:chgData name="宏矩 北島" userId="030d870b973acc8b" providerId="LiveId" clId="{E7CC9A60-A8ED-4DDA-80F5-5F3EEAC3FE68}" dt="2024-11-18T07:51:38.787" v="1" actId="114"/>
        <pc:sldMkLst>
          <pc:docMk/>
          <pc:sldMk cId="3388654472" sldId="258"/>
        </pc:sldMkLst>
        <pc:spChg chg="mod">
          <ac:chgData name="宏矩 北島" userId="030d870b973acc8b" providerId="LiveId" clId="{E7CC9A60-A8ED-4DDA-80F5-5F3EEAC3FE68}" dt="2024-11-18T07:51:38.787" v="1" actId="114"/>
          <ac:spMkLst>
            <pc:docMk/>
            <pc:sldMk cId="3388654472" sldId="258"/>
            <ac:spMk id="6" creationId="{D626A0C2-6FFC-36AD-C64D-31D159A65843}"/>
          </ac:spMkLst>
        </pc:spChg>
      </pc:sldChg>
      <pc:sldChg chg="modSp mod">
        <pc:chgData name="宏矩 北島" userId="030d870b973acc8b" providerId="LiveId" clId="{E7CC9A60-A8ED-4DDA-80F5-5F3EEAC3FE68}" dt="2024-11-18T07:51:49.061" v="3" actId="114"/>
        <pc:sldMkLst>
          <pc:docMk/>
          <pc:sldMk cId="3857924030" sldId="259"/>
        </pc:sldMkLst>
        <pc:spChg chg="mod">
          <ac:chgData name="宏矩 北島" userId="030d870b973acc8b" providerId="LiveId" clId="{E7CC9A60-A8ED-4DDA-80F5-5F3EEAC3FE68}" dt="2024-11-18T07:51:49.061" v="3" actId="114"/>
          <ac:spMkLst>
            <pc:docMk/>
            <pc:sldMk cId="3857924030" sldId="259"/>
            <ac:spMk id="6" creationId="{65E15C81-D9C9-D28B-E3A8-7641012A1585}"/>
          </ac:spMkLst>
        </pc:spChg>
      </pc:sldChg>
      <pc:sldChg chg="modSp mod">
        <pc:chgData name="宏矩 北島" userId="030d870b973acc8b" providerId="LiveId" clId="{E7CC9A60-A8ED-4DDA-80F5-5F3EEAC3FE68}" dt="2024-11-18T07:51:53.044" v="4" actId="114"/>
        <pc:sldMkLst>
          <pc:docMk/>
          <pc:sldMk cId="2805215091" sldId="260"/>
        </pc:sldMkLst>
        <pc:spChg chg="mod">
          <ac:chgData name="宏矩 北島" userId="030d870b973acc8b" providerId="LiveId" clId="{E7CC9A60-A8ED-4DDA-80F5-5F3EEAC3FE68}" dt="2024-11-18T07:51:53.044" v="4" actId="114"/>
          <ac:spMkLst>
            <pc:docMk/>
            <pc:sldMk cId="2805215091" sldId="260"/>
            <ac:spMk id="9" creationId="{6A6DB9C3-5DB9-15C5-58E6-985C771EA638}"/>
          </ac:spMkLst>
        </pc:spChg>
      </pc:sldChg>
      <pc:sldChg chg="modSp mod">
        <pc:chgData name="宏矩 北島" userId="030d870b973acc8b" providerId="LiveId" clId="{E7CC9A60-A8ED-4DDA-80F5-5F3EEAC3FE68}" dt="2024-11-18T07:51:55.876" v="5" actId="114"/>
        <pc:sldMkLst>
          <pc:docMk/>
          <pc:sldMk cId="1653331156" sldId="261"/>
        </pc:sldMkLst>
        <pc:spChg chg="mod">
          <ac:chgData name="宏矩 北島" userId="030d870b973acc8b" providerId="LiveId" clId="{E7CC9A60-A8ED-4DDA-80F5-5F3EEAC3FE68}" dt="2024-11-18T07:51:55.876" v="5" actId="114"/>
          <ac:spMkLst>
            <pc:docMk/>
            <pc:sldMk cId="1653331156" sldId="261"/>
            <ac:spMk id="5" creationId="{7E58B3BE-B772-76D4-B140-CFA854F87B70}"/>
          </ac:spMkLst>
        </pc:spChg>
      </pc:sldChg>
    </pc:docChg>
  </pc:docChgLst>
  <pc:docChgLst>
    <pc:chgData name="宏矩 北島" userId="030d870b973acc8b" providerId="LiveId" clId="{1F880295-3493-480D-AB4B-A4710B354A24}"/>
    <pc:docChg chg="undo custSel addSld modSld sldOrd">
      <pc:chgData name="宏矩 北島" userId="030d870b973acc8b" providerId="LiveId" clId="{1F880295-3493-480D-AB4B-A4710B354A24}" dt="2024-11-17T02:25:42.344" v="167"/>
      <pc:docMkLst>
        <pc:docMk/>
      </pc:docMkLst>
      <pc:sldChg chg="addSp delSp modSp mod">
        <pc:chgData name="宏矩 北島" userId="030d870b973acc8b" providerId="LiveId" clId="{1F880295-3493-480D-AB4B-A4710B354A24}" dt="2024-11-17T02:24:22.563" v="132"/>
        <pc:sldMkLst>
          <pc:docMk/>
          <pc:sldMk cId="2169076646" sldId="256"/>
        </pc:sldMkLst>
        <pc:spChg chg="add mod">
          <ac:chgData name="宏矩 北島" userId="030d870b973acc8b" providerId="LiveId" clId="{1F880295-3493-480D-AB4B-A4710B354A24}" dt="2024-11-17T02:24:22.563" v="132"/>
          <ac:spMkLst>
            <pc:docMk/>
            <pc:sldMk cId="2169076646" sldId="256"/>
            <ac:spMk id="6" creationId="{B1770FD2-2FAC-6946-211B-F10CA6C86338}"/>
          </ac:spMkLst>
        </pc:spChg>
        <pc:graphicFrameChg chg="add del mod">
          <ac:chgData name="宏矩 北島" userId="030d870b973acc8b" providerId="LiveId" clId="{1F880295-3493-480D-AB4B-A4710B354A24}" dt="2024-11-17T02:15:17.966" v="61" actId="1076"/>
          <ac:graphicFrameMkLst>
            <pc:docMk/>
            <pc:sldMk cId="2169076646" sldId="256"/>
            <ac:graphicFrameMk id="4" creationId="{5F91502C-C47F-60CF-FAE2-9E5153CCFD38}"/>
          </ac:graphicFrameMkLst>
        </pc:graphicFrameChg>
        <pc:graphicFrameChg chg="add del mod">
          <ac:chgData name="宏矩 北島" userId="030d870b973acc8b" providerId="LiveId" clId="{1F880295-3493-480D-AB4B-A4710B354A24}" dt="2024-11-17T02:15:17.966" v="61" actId="1076"/>
          <ac:graphicFrameMkLst>
            <pc:docMk/>
            <pc:sldMk cId="2169076646" sldId="256"/>
            <ac:graphicFrameMk id="5" creationId="{B3A136E1-43ED-15D7-2918-F674BEC710ED}"/>
          </ac:graphicFrameMkLst>
        </pc:graphicFrameChg>
      </pc:sldChg>
      <pc:sldChg chg="addSp modSp mod">
        <pc:chgData name="宏矩 北島" userId="030d870b973acc8b" providerId="LiveId" clId="{1F880295-3493-480D-AB4B-A4710B354A24}" dt="2024-11-17T02:23:42.375" v="131" actId="1076"/>
        <pc:sldMkLst>
          <pc:docMk/>
          <pc:sldMk cId="2197144160" sldId="257"/>
        </pc:sldMkLst>
        <pc:spChg chg="add mod">
          <ac:chgData name="宏矩 北島" userId="030d870b973acc8b" providerId="LiveId" clId="{1F880295-3493-480D-AB4B-A4710B354A24}" dt="2024-11-17T02:23:42.375" v="131" actId="1076"/>
          <ac:spMkLst>
            <pc:docMk/>
            <pc:sldMk cId="2197144160" sldId="257"/>
            <ac:spMk id="6" creationId="{AECC1755-FDB8-C2D5-8CAB-362C44245C53}"/>
          </ac:spMkLst>
        </pc:spChg>
        <pc:graphicFrameChg chg="add mod">
          <ac:chgData name="宏矩 北島" userId="030d870b973acc8b" providerId="LiveId" clId="{1F880295-3493-480D-AB4B-A4710B354A24}" dt="2024-11-17T02:15:34.600" v="65" actId="1076"/>
          <ac:graphicFrameMkLst>
            <pc:docMk/>
            <pc:sldMk cId="2197144160" sldId="257"/>
            <ac:graphicFrameMk id="4" creationId="{CB5C6153-678D-F043-DC48-84BBDA365A24}"/>
          </ac:graphicFrameMkLst>
        </pc:graphicFrameChg>
      </pc:sldChg>
      <pc:sldChg chg="addSp delSp modSp new mod ord">
        <pc:chgData name="宏矩 北島" userId="030d870b973acc8b" providerId="LiveId" clId="{1F880295-3493-480D-AB4B-A4710B354A24}" dt="2024-11-17T02:24:41.597" v="134" actId="1076"/>
        <pc:sldMkLst>
          <pc:docMk/>
          <pc:sldMk cId="3388654472" sldId="258"/>
        </pc:sldMkLst>
        <pc:spChg chg="del">
          <ac:chgData name="宏矩 北島" userId="030d870b973acc8b" providerId="LiveId" clId="{1F880295-3493-480D-AB4B-A4710B354A24}" dt="2024-11-17T02:03:41.318" v="4" actId="478"/>
          <ac:spMkLst>
            <pc:docMk/>
            <pc:sldMk cId="3388654472" sldId="258"/>
            <ac:spMk id="2" creationId="{1118B430-C179-FB8D-D184-838036EC33FA}"/>
          </ac:spMkLst>
        </pc:spChg>
        <pc:spChg chg="del">
          <ac:chgData name="宏矩 北島" userId="030d870b973acc8b" providerId="LiveId" clId="{1F880295-3493-480D-AB4B-A4710B354A24}" dt="2024-11-17T02:03:42.780" v="5" actId="478"/>
          <ac:spMkLst>
            <pc:docMk/>
            <pc:sldMk cId="3388654472" sldId="258"/>
            <ac:spMk id="3" creationId="{4D19BE45-8A37-591B-3D7F-E7D3573263BE}"/>
          </ac:spMkLst>
        </pc:spChg>
        <pc:spChg chg="add mod">
          <ac:chgData name="宏矩 北島" userId="030d870b973acc8b" providerId="LiveId" clId="{1F880295-3493-480D-AB4B-A4710B354A24}" dt="2024-11-17T02:24:41.597" v="134" actId="1076"/>
          <ac:spMkLst>
            <pc:docMk/>
            <pc:sldMk cId="3388654472" sldId="258"/>
            <ac:spMk id="6" creationId="{D626A0C2-6FFC-36AD-C64D-31D159A65843}"/>
          </ac:spMkLst>
        </pc:spChg>
        <pc:graphicFrameChg chg="add mod">
          <ac:chgData name="宏矩 北島" userId="030d870b973acc8b" providerId="LiveId" clId="{1F880295-3493-480D-AB4B-A4710B354A24}" dt="2024-11-17T02:15:30.238" v="64" actId="1076"/>
          <ac:graphicFrameMkLst>
            <pc:docMk/>
            <pc:sldMk cId="3388654472" sldId="258"/>
            <ac:graphicFrameMk id="4" creationId="{6DA60DBC-C56B-9331-2BEB-8CA3DE980AE5}"/>
          </ac:graphicFrameMkLst>
        </pc:graphicFrameChg>
        <pc:graphicFrameChg chg="add mod">
          <ac:chgData name="宏矩 北島" userId="030d870b973acc8b" providerId="LiveId" clId="{1F880295-3493-480D-AB4B-A4710B354A24}" dt="2024-11-17T02:15:30.238" v="64" actId="1076"/>
          <ac:graphicFrameMkLst>
            <pc:docMk/>
            <pc:sldMk cId="3388654472" sldId="258"/>
            <ac:graphicFrameMk id="5" creationId="{2FB4BE2B-955B-CFBC-0CC4-7A5A1979C6A2}"/>
          </ac:graphicFrameMkLst>
        </pc:graphicFrameChg>
      </pc:sldChg>
      <pc:sldChg chg="addSp delSp modSp new mod">
        <pc:chgData name="宏矩 北島" userId="030d870b973acc8b" providerId="LiveId" clId="{1F880295-3493-480D-AB4B-A4710B354A24}" dt="2024-11-17T02:24:45.213" v="135"/>
        <pc:sldMkLst>
          <pc:docMk/>
          <pc:sldMk cId="3857924030" sldId="259"/>
        </pc:sldMkLst>
        <pc:spChg chg="del">
          <ac:chgData name="宏矩 北島" userId="030d870b973acc8b" providerId="LiveId" clId="{1F880295-3493-480D-AB4B-A4710B354A24}" dt="2024-11-17T02:06:06.281" v="20" actId="478"/>
          <ac:spMkLst>
            <pc:docMk/>
            <pc:sldMk cId="3857924030" sldId="259"/>
            <ac:spMk id="2" creationId="{6805C31C-40D4-20D1-C174-29984DF41A2D}"/>
          </ac:spMkLst>
        </pc:spChg>
        <pc:spChg chg="del">
          <ac:chgData name="宏矩 北島" userId="030d870b973acc8b" providerId="LiveId" clId="{1F880295-3493-480D-AB4B-A4710B354A24}" dt="2024-11-17T02:06:07.400" v="21" actId="478"/>
          <ac:spMkLst>
            <pc:docMk/>
            <pc:sldMk cId="3857924030" sldId="259"/>
            <ac:spMk id="3" creationId="{FB6425B7-B9A8-4F7D-0285-CFD0F0515AF4}"/>
          </ac:spMkLst>
        </pc:spChg>
        <pc:spChg chg="add mod">
          <ac:chgData name="宏矩 北島" userId="030d870b973acc8b" providerId="LiveId" clId="{1F880295-3493-480D-AB4B-A4710B354A24}" dt="2024-11-17T02:24:45.213" v="135"/>
          <ac:spMkLst>
            <pc:docMk/>
            <pc:sldMk cId="3857924030" sldId="259"/>
            <ac:spMk id="6" creationId="{65E15C81-D9C9-D28B-E3A8-7641012A1585}"/>
          </ac:spMkLst>
        </pc:spChg>
        <pc:graphicFrameChg chg="add mod">
          <ac:chgData name="宏矩 北島" userId="030d870b973acc8b" providerId="LiveId" clId="{1F880295-3493-480D-AB4B-A4710B354A24}" dt="2024-11-17T02:15:43.567" v="68" actId="14100"/>
          <ac:graphicFrameMkLst>
            <pc:docMk/>
            <pc:sldMk cId="3857924030" sldId="259"/>
            <ac:graphicFrameMk id="4" creationId="{DD9BDB3D-23E4-ED29-4CE6-08F34EB40D73}"/>
          </ac:graphicFrameMkLst>
        </pc:graphicFrameChg>
        <pc:graphicFrameChg chg="add mod">
          <ac:chgData name="宏矩 北島" userId="030d870b973acc8b" providerId="LiveId" clId="{1F880295-3493-480D-AB4B-A4710B354A24}" dt="2024-11-17T02:15:45.911" v="69" actId="14100"/>
          <ac:graphicFrameMkLst>
            <pc:docMk/>
            <pc:sldMk cId="3857924030" sldId="259"/>
            <ac:graphicFrameMk id="5" creationId="{8A44F892-6F7A-18D4-ED15-9EA3EEE9C4F0}"/>
          </ac:graphicFrameMkLst>
        </pc:graphicFrameChg>
      </pc:sldChg>
      <pc:sldChg chg="addSp delSp modSp new mod">
        <pc:chgData name="宏矩 北島" userId="030d870b973acc8b" providerId="LiveId" clId="{1F880295-3493-480D-AB4B-A4710B354A24}" dt="2024-11-17T02:25:23.847" v="163" actId="1036"/>
        <pc:sldMkLst>
          <pc:docMk/>
          <pc:sldMk cId="2805215091" sldId="260"/>
        </pc:sldMkLst>
        <pc:spChg chg="del">
          <ac:chgData name="宏矩 北島" userId="030d870b973acc8b" providerId="LiveId" clId="{1F880295-3493-480D-AB4B-A4710B354A24}" dt="2024-11-17T02:08:29.544" v="34" actId="478"/>
          <ac:spMkLst>
            <pc:docMk/>
            <pc:sldMk cId="2805215091" sldId="260"/>
            <ac:spMk id="2" creationId="{E0D28C06-0A34-E5EE-EA9C-E160407989B0}"/>
          </ac:spMkLst>
        </pc:spChg>
        <pc:spChg chg="del">
          <ac:chgData name="宏矩 北島" userId="030d870b973acc8b" providerId="LiveId" clId="{1F880295-3493-480D-AB4B-A4710B354A24}" dt="2024-11-17T02:08:29.026" v="33" actId="478"/>
          <ac:spMkLst>
            <pc:docMk/>
            <pc:sldMk cId="2805215091" sldId="260"/>
            <ac:spMk id="3" creationId="{B65A50EE-B0E9-ECC6-176F-6BB28D696BFE}"/>
          </ac:spMkLst>
        </pc:spChg>
        <pc:spChg chg="add mod">
          <ac:chgData name="宏矩 北島" userId="030d870b973acc8b" providerId="LiveId" clId="{1F880295-3493-480D-AB4B-A4710B354A24}" dt="2024-11-17T02:24:55.113" v="136"/>
          <ac:spMkLst>
            <pc:docMk/>
            <pc:sldMk cId="2805215091" sldId="260"/>
            <ac:spMk id="9" creationId="{6A6DB9C3-5DB9-15C5-58E6-985C771EA638}"/>
          </ac:spMkLst>
        </pc:spChg>
        <pc:graphicFrameChg chg="add del mod">
          <ac:chgData name="宏矩 北島" userId="030d870b973acc8b" providerId="LiveId" clId="{1F880295-3493-480D-AB4B-A4710B354A24}" dt="2024-11-17T02:11:19.740" v="38" actId="478"/>
          <ac:graphicFrameMkLst>
            <pc:docMk/>
            <pc:sldMk cId="2805215091" sldId="260"/>
            <ac:graphicFrameMk id="4" creationId="{8F1AFFEC-8EE4-0831-02B7-2565C7009FAC}"/>
          </ac:graphicFrameMkLst>
        </pc:graphicFrameChg>
        <pc:graphicFrameChg chg="add mod">
          <ac:chgData name="宏矩 北島" userId="030d870b973acc8b" providerId="LiveId" clId="{1F880295-3493-480D-AB4B-A4710B354A24}" dt="2024-11-17T02:25:23.847" v="163" actId="1036"/>
          <ac:graphicFrameMkLst>
            <pc:docMk/>
            <pc:sldMk cId="2805215091" sldId="260"/>
            <ac:graphicFrameMk id="5" creationId="{EB9B4603-ED50-FFC6-1759-1EDEC2812AD7}"/>
          </ac:graphicFrameMkLst>
        </pc:graphicFrameChg>
        <pc:graphicFrameChg chg="add mod">
          <ac:chgData name="宏矩 北島" userId="030d870b973acc8b" providerId="LiveId" clId="{1F880295-3493-480D-AB4B-A4710B354A24}" dt="2024-11-17T02:25:23.847" v="163" actId="1036"/>
          <ac:graphicFrameMkLst>
            <pc:docMk/>
            <pc:sldMk cId="2805215091" sldId="260"/>
            <ac:graphicFrameMk id="6" creationId="{A646CE96-BEE7-B8BB-C6BD-578D0587D10D}"/>
          </ac:graphicFrameMkLst>
        </pc:graphicFrameChg>
        <pc:graphicFrameChg chg="add mod">
          <ac:chgData name="宏矩 北島" userId="030d870b973acc8b" providerId="LiveId" clId="{1F880295-3493-480D-AB4B-A4710B354A24}" dt="2024-11-17T02:25:23.847" v="163" actId="1036"/>
          <ac:graphicFrameMkLst>
            <pc:docMk/>
            <pc:sldMk cId="2805215091" sldId="260"/>
            <ac:graphicFrameMk id="7" creationId="{6AFFAD47-2B9E-3445-A4A6-C504D1A15A1D}"/>
          </ac:graphicFrameMkLst>
        </pc:graphicFrameChg>
        <pc:graphicFrameChg chg="add mod">
          <ac:chgData name="宏矩 北島" userId="030d870b973acc8b" providerId="LiveId" clId="{1F880295-3493-480D-AB4B-A4710B354A24}" dt="2024-11-17T02:25:23.847" v="163" actId="1036"/>
          <ac:graphicFrameMkLst>
            <pc:docMk/>
            <pc:sldMk cId="2805215091" sldId="260"/>
            <ac:graphicFrameMk id="8" creationId="{08EB6301-6F1C-3848-6EA5-00A9E286F577}"/>
          </ac:graphicFrameMkLst>
        </pc:graphicFrameChg>
      </pc:sldChg>
      <pc:sldChg chg="addSp delSp modSp new mod">
        <pc:chgData name="宏矩 北島" userId="030d870b973acc8b" providerId="LiveId" clId="{1F880295-3493-480D-AB4B-A4710B354A24}" dt="2024-11-17T02:25:42.344" v="167"/>
        <pc:sldMkLst>
          <pc:docMk/>
          <pc:sldMk cId="1653331156" sldId="261"/>
        </pc:sldMkLst>
        <pc:spChg chg="del">
          <ac:chgData name="宏矩 北島" userId="030d870b973acc8b" providerId="LiveId" clId="{1F880295-3493-480D-AB4B-A4710B354A24}" dt="2024-11-17T02:14:07.295" v="51" actId="478"/>
          <ac:spMkLst>
            <pc:docMk/>
            <pc:sldMk cId="1653331156" sldId="261"/>
            <ac:spMk id="2" creationId="{1233A135-E382-DD35-BDFB-D6D189C30032}"/>
          </ac:spMkLst>
        </pc:spChg>
        <pc:spChg chg="del">
          <ac:chgData name="宏矩 北島" userId="030d870b973acc8b" providerId="LiveId" clId="{1F880295-3493-480D-AB4B-A4710B354A24}" dt="2024-11-17T02:14:08.285" v="52" actId="478"/>
          <ac:spMkLst>
            <pc:docMk/>
            <pc:sldMk cId="1653331156" sldId="261"/>
            <ac:spMk id="3" creationId="{95FBE586-F165-D195-F652-126162AEEA15}"/>
          </ac:spMkLst>
        </pc:spChg>
        <pc:spChg chg="add mod">
          <ac:chgData name="宏矩 北島" userId="030d870b973acc8b" providerId="LiveId" clId="{1F880295-3493-480D-AB4B-A4710B354A24}" dt="2024-11-17T02:25:42.344" v="167"/>
          <ac:spMkLst>
            <pc:docMk/>
            <pc:sldMk cId="1653331156" sldId="261"/>
            <ac:spMk id="5" creationId="{7E58B3BE-B772-76D4-B140-CFA854F87B70}"/>
          </ac:spMkLst>
        </pc:spChg>
        <pc:graphicFrameChg chg="add mod">
          <ac:chgData name="宏矩 北島" userId="030d870b973acc8b" providerId="LiveId" clId="{1F880295-3493-480D-AB4B-A4710B354A24}" dt="2024-11-17T02:25:40.441" v="166" actId="1076"/>
          <ac:graphicFrameMkLst>
            <pc:docMk/>
            <pc:sldMk cId="1653331156" sldId="261"/>
            <ac:graphicFrameMk id="4" creationId="{953A75C6-8B03-CC7C-9694-919F20C83BA9}"/>
          </ac:graphicFrameMkLst>
        </pc:graphicFrame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C83CB856-B2DD-F595-AC0C-2F2ACBE3023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15AC1F28-6376-9604-9117-B8A3C1E8945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3ED530B-A30E-AA48-7DB7-7AE83709A0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C1D0E-002A-465B-B6B3-E71651E17247}" type="datetimeFigureOut">
              <a:rPr kumimoji="1" lang="ja-JP" altLang="en-US" smtClean="0"/>
              <a:t>2024/11/1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D43777F8-3139-7F3D-5BF8-46F8C34D44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11B61C7-D6E8-2163-31C6-7D9AE01E36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CAC9B6-A7ED-4446-928C-ACEC422D851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315174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69AA59A-309E-74CB-C0B7-100A7F5C67F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4B491761-73D1-0FFE-8E58-E54C35E8696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B271762-4C20-87C8-E309-7A25EA28B0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C1D0E-002A-465B-B6B3-E71651E17247}" type="datetimeFigureOut">
              <a:rPr kumimoji="1" lang="ja-JP" altLang="en-US" smtClean="0"/>
              <a:t>2024/11/1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A7A5D98-77DC-4B31-3598-47FC692101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08D1035-6328-3CA7-2587-E1F3DB49D8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CAC9B6-A7ED-4446-928C-ACEC422D851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084670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4CC3BDEF-23F8-E39C-D019-9B759A69BF2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5C596F84-A699-6853-CB9E-EC660D0EE25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D633ABFC-AFEB-7FC2-2F89-1AF720AF24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C1D0E-002A-465B-B6B3-E71651E17247}" type="datetimeFigureOut">
              <a:rPr kumimoji="1" lang="ja-JP" altLang="en-US" smtClean="0"/>
              <a:t>2024/11/1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77B622F-9172-A141-526F-B58EDEC09F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7B0ACCE2-2C23-F768-3F98-C8AECEE89F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CAC9B6-A7ED-4446-928C-ACEC422D851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049683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326BDE4-ECB8-B24C-26D9-9C775CDBE40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FBE14EC2-6973-5336-A01D-52883CC07B8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8CD58AB5-42F7-152F-BED5-84EF3E772BE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C1D0E-002A-465B-B6B3-E71651E17247}" type="datetimeFigureOut">
              <a:rPr kumimoji="1" lang="ja-JP" altLang="en-US" smtClean="0"/>
              <a:t>2024/11/1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6151CBF-88DE-052D-2859-B933ED387DA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F42208E-3FBE-5F93-FA87-8F1B1E77CFE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CAC9B6-A7ED-4446-928C-ACEC422D851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0048431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F460926-509C-2953-A8AE-F9665D27A8A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943D78B4-A8A8-2FC7-1D8C-A881A2C0766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789513FC-4FF5-CD34-F69E-93F814EA55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C1D0E-002A-465B-B6B3-E71651E17247}" type="datetimeFigureOut">
              <a:rPr kumimoji="1" lang="ja-JP" altLang="en-US" smtClean="0"/>
              <a:t>2024/11/1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8D77AE8F-2ABF-E827-8BE7-5FE969AB28D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37047DD-56CF-CF39-349E-0615FFF455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CAC9B6-A7ED-4446-928C-ACEC422D851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793479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E0DF432-3D8F-0009-C9DC-ADB783230F2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63079B2E-8D61-0EA9-658D-2937763AB14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9ECB93C4-5E9B-9EF3-8A85-7551CDDD42A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3FFB0E2F-B604-6C05-5B88-51F673D2D03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C1D0E-002A-465B-B6B3-E71651E17247}" type="datetimeFigureOut">
              <a:rPr kumimoji="1" lang="ja-JP" altLang="en-US" smtClean="0"/>
              <a:t>2024/11/1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C36B876B-A4D4-AF62-4A5B-524E3CE601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D1055F3A-59DD-97A9-EE4D-7246C92393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CAC9B6-A7ED-4446-928C-ACEC422D851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8110155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E5CF8C6-7752-2603-5836-96DB3CE7AA6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AC757D5C-AAF5-694A-7267-E587C65CB25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167C17E6-9F74-063C-8453-B00385EB96E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9F74A12E-D39F-99AE-5518-F456D7CA329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8EBBC988-1923-50E4-D0C7-260C9125D6B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14B2AAA1-6ED5-ED4A-4BE9-54AC8169FB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C1D0E-002A-465B-B6B3-E71651E17247}" type="datetimeFigureOut">
              <a:rPr kumimoji="1" lang="ja-JP" altLang="en-US" smtClean="0"/>
              <a:t>2024/11/19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191F3D24-AFFF-BFAD-57EA-6DB0548B32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8FB9A3C7-2ED5-200F-71DC-8003FE94F1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CAC9B6-A7ED-4446-928C-ACEC422D851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592276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DFFFD449-FFA5-9E49-3F56-739AA8FFFA9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1C0CA5DE-5242-C52E-D71D-13BAE2394C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C1D0E-002A-465B-B6B3-E71651E17247}" type="datetimeFigureOut">
              <a:rPr kumimoji="1" lang="ja-JP" altLang="en-US" smtClean="0"/>
              <a:t>2024/11/19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BAFDB421-A0D2-A883-4223-BFA37A59A3E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21FE20A9-5EDC-956D-F900-8373C4668E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CAC9B6-A7ED-4446-928C-ACEC422D851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000307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B8F0CE0D-F26F-A997-9EB3-510AA685E2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C1D0E-002A-465B-B6B3-E71651E17247}" type="datetimeFigureOut">
              <a:rPr kumimoji="1" lang="ja-JP" altLang="en-US" smtClean="0"/>
              <a:t>2024/11/19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5E3003A6-48DC-1075-72A9-99C84AB834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F4327BE3-D89A-79EA-4614-152D39F7FDD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CAC9B6-A7ED-4446-928C-ACEC422D851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516006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67FF2B9-5AA1-A27B-DC3E-C58319A622A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681B7900-D3B8-0E9C-B6B3-6AE66348CCE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62773F60-2C75-5F8C-51D0-48988EAD4EB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CD669397-E4F1-BE60-FF86-673B914322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C1D0E-002A-465B-B6B3-E71651E17247}" type="datetimeFigureOut">
              <a:rPr kumimoji="1" lang="ja-JP" altLang="en-US" smtClean="0"/>
              <a:t>2024/11/1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C1C72DE2-8470-ECA4-CFF3-0B4C0EB765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85DE6A9A-E03C-5B31-CB52-B411AE7622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CAC9B6-A7ED-4446-928C-ACEC422D851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4033799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5281791-E03A-8A8A-3126-DD7D189F9FD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0E03B7D8-96C2-0175-8BAA-B8975D2AB59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F6742119-7504-C711-6ECA-E1B0B7AEA42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39E7473C-BC35-590E-2C1D-D1190E9F91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01C1D0E-002A-465B-B6B3-E71651E17247}" type="datetimeFigureOut">
              <a:rPr kumimoji="1" lang="ja-JP" altLang="en-US" smtClean="0"/>
              <a:t>2024/11/19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03BC1497-EB2F-A5BD-5F33-69FB787DE56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2B2E14D0-9BE6-DAB2-DECF-6A72F360CB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5CAC9B6-A7ED-4446-928C-ACEC422D851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8211661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ED2308A5-BF26-98DA-95D7-C039FCB7732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6131E39F-A899-0F5F-F26D-075A4C19B6A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EB194874-30A8-3AF2-6FBE-3C4D6022AE7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01C1D0E-002A-465B-B6B3-E71651E17247}" type="datetimeFigureOut">
              <a:rPr kumimoji="1" lang="ja-JP" altLang="en-US" smtClean="0"/>
              <a:t>2024/11/19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3CA8BF8-5F4F-2674-50D7-FA8FC9D7E00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F1AB439-1FCA-FC79-D5B2-704600FBEBD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5CAC9B6-A7ED-4446-928C-ACEC422D851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185274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.emf"/><Relationship Id="rId4" Type="http://schemas.openxmlformats.org/officeDocument/2006/relationships/oleObject" Target="../embeddings/oleObject2.bin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oleObject" Target="../embeddings/oleObject3.bin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emf"/><Relationship Id="rId4" Type="http://schemas.openxmlformats.org/officeDocument/2006/relationships/oleObject" Target="../embeddings/oleObject4.bin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emf"/><Relationship Id="rId2" Type="http://schemas.openxmlformats.org/officeDocument/2006/relationships/oleObject" Target="../embeddings/oleObject5.bin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2" Type="http://schemas.openxmlformats.org/officeDocument/2006/relationships/oleObject" Target="../embeddings/oleObject6.bin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7.emf"/><Relationship Id="rId4" Type="http://schemas.openxmlformats.org/officeDocument/2006/relationships/oleObject" Target="../embeddings/oleObject7.bin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11.bin"/><Relationship Id="rId3" Type="http://schemas.openxmlformats.org/officeDocument/2006/relationships/image" Target="../media/image8.emf"/><Relationship Id="rId7" Type="http://schemas.openxmlformats.org/officeDocument/2006/relationships/image" Target="../media/image10.emf"/><Relationship Id="rId2" Type="http://schemas.openxmlformats.org/officeDocument/2006/relationships/oleObject" Target="../embeddings/oleObject8.bin"/><Relationship Id="rId1" Type="http://schemas.openxmlformats.org/officeDocument/2006/relationships/slideLayout" Target="../slideLayouts/slideLayout2.xml"/><Relationship Id="rId6" Type="http://schemas.openxmlformats.org/officeDocument/2006/relationships/oleObject" Target="../embeddings/oleObject10.bin"/><Relationship Id="rId5" Type="http://schemas.openxmlformats.org/officeDocument/2006/relationships/image" Target="../media/image9.emf"/><Relationship Id="rId4" Type="http://schemas.openxmlformats.org/officeDocument/2006/relationships/oleObject" Target="../embeddings/oleObject9.bin"/><Relationship Id="rId9" Type="http://schemas.openxmlformats.org/officeDocument/2006/relationships/image" Target="../media/image11.em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emf"/><Relationship Id="rId2" Type="http://schemas.openxmlformats.org/officeDocument/2006/relationships/oleObject" Target="../embeddings/oleObject12.bin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オブジェクト 3">
            <a:extLst>
              <a:ext uri="{FF2B5EF4-FFF2-40B4-BE49-F238E27FC236}">
                <a16:creationId xmlns:a16="http://schemas.microsoft.com/office/drawing/2014/main" id="{5F91502C-C47F-60CF-FAE2-9E5153CCFD38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69888400"/>
              </p:ext>
            </p:extLst>
          </p:nvPr>
        </p:nvGraphicFramePr>
        <p:xfrm>
          <a:off x="2053119" y="139104"/>
          <a:ext cx="3101547" cy="56791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1860101" imgH="3406766" progId="Prism9.Document">
                  <p:embed/>
                </p:oleObj>
              </mc:Choice>
              <mc:Fallback>
                <p:oleObj name="Prism 9" r:id="rId2" imgW="1860101" imgH="3406766" progId="Prism9.Document">
                  <p:embed/>
                  <p:pic>
                    <p:nvPicPr>
                      <p:cNvPr id="4" name="オブジェクト 3">
                        <a:extLst>
                          <a:ext uri="{FF2B5EF4-FFF2-40B4-BE49-F238E27FC236}">
                            <a16:creationId xmlns:a16="http://schemas.microsoft.com/office/drawing/2014/main" id="{5F91502C-C47F-60CF-FAE2-9E5153CCFD38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2053119" y="139104"/>
                        <a:ext cx="3101547" cy="56791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オブジェクト 4">
            <a:extLst>
              <a:ext uri="{FF2B5EF4-FFF2-40B4-BE49-F238E27FC236}">
                <a16:creationId xmlns:a16="http://schemas.microsoft.com/office/drawing/2014/main" id="{B3A136E1-43ED-15D7-2918-F674BEC710E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33983592"/>
              </p:ext>
            </p:extLst>
          </p:nvPr>
        </p:nvGraphicFramePr>
        <p:xfrm>
          <a:off x="6428317" y="139105"/>
          <a:ext cx="3305630" cy="554361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4" imgW="1942212" imgH="3255546" progId="Prism9.Document">
                  <p:embed/>
                </p:oleObj>
              </mc:Choice>
              <mc:Fallback>
                <p:oleObj name="Prism 9" r:id="rId4" imgW="1942212" imgH="3255546" progId="Prism9.Document">
                  <p:embed/>
                  <p:pic>
                    <p:nvPicPr>
                      <p:cNvPr id="5" name="オブジェクト 4">
                        <a:extLst>
                          <a:ext uri="{FF2B5EF4-FFF2-40B4-BE49-F238E27FC236}">
                            <a16:creationId xmlns:a16="http://schemas.microsoft.com/office/drawing/2014/main" id="{B3A136E1-43ED-15D7-2918-F674BEC710E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6428317" y="139105"/>
                        <a:ext cx="3305630" cy="554361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B1770FD2-2FAC-6946-211B-F10CA6C86338}"/>
              </a:ext>
            </a:extLst>
          </p:cNvPr>
          <p:cNvSpPr txBox="1"/>
          <p:nvPr/>
        </p:nvSpPr>
        <p:spPr>
          <a:xfrm>
            <a:off x="1898650" y="5647806"/>
            <a:ext cx="9059333" cy="12003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dirty="0">
                <a:solidFill>
                  <a:srgbClr val="222222"/>
                </a:solidFill>
                <a:latin typeface="Arial" panose="020B0604020202020204" pitchFamily="34" charset="0"/>
              </a:rPr>
              <a:t>Figure S1. Bar graphs are used to show the change in the results of Table 2.</a:t>
            </a:r>
          </a:p>
          <a:p>
            <a:endParaRPr lang="en-US" altLang="ja-JP" dirty="0">
              <a:solidFill>
                <a:srgbClr val="222222"/>
              </a:solidFill>
              <a:latin typeface="Arial" panose="020B0604020202020204" pitchFamily="34" charset="0"/>
            </a:endParaRPr>
          </a:p>
          <a:p>
            <a:r>
              <a:rPr lang="en-US" altLang="ja-JP" dirty="0">
                <a:solidFill>
                  <a:srgbClr val="222222"/>
                </a:solidFill>
                <a:latin typeface="Arial" panose="020B0604020202020204" pitchFamily="34" charset="0"/>
              </a:rPr>
              <a:t>ns</a:t>
            </a:r>
            <a:r>
              <a:rPr lang="en-US" altLang="ja-JP" b="0" i="0" dirty="0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 </a:t>
            </a:r>
            <a:r>
              <a:rPr lang="en-US" altLang="ja-JP" b="0" i="1" dirty="0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p</a:t>
            </a:r>
            <a:r>
              <a:rPr lang="en-US" altLang="ja-JP" b="0" i="0" dirty="0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 </a:t>
            </a:r>
            <a:r>
              <a:rPr lang="ja-JP" altLang="en-US" b="0" i="0" dirty="0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≧</a:t>
            </a:r>
            <a:r>
              <a:rPr lang="en-US" altLang="ja-JP" b="0" i="0" dirty="0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 0.05, * </a:t>
            </a:r>
            <a:r>
              <a:rPr lang="en-US" altLang="ja-JP" b="0" i="1" dirty="0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p</a:t>
            </a:r>
            <a:r>
              <a:rPr lang="en-US" altLang="ja-JP" b="0" i="0" dirty="0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 &lt; 0.05, ** </a:t>
            </a:r>
            <a:r>
              <a:rPr lang="en-US" altLang="ja-JP" b="0" i="1" dirty="0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p</a:t>
            </a:r>
            <a:r>
              <a:rPr lang="en-US" altLang="ja-JP" b="0" i="0" dirty="0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 &lt; 0.01, *** </a:t>
            </a:r>
            <a:r>
              <a:rPr lang="en-US" altLang="ja-JP" b="0" i="1" dirty="0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p</a:t>
            </a:r>
            <a:r>
              <a:rPr lang="en-US" altLang="ja-JP" b="0" i="0" dirty="0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 &lt; 0.001, **** </a:t>
            </a:r>
            <a:r>
              <a:rPr lang="en-US" altLang="ja-JP" b="0" i="1" dirty="0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p</a:t>
            </a:r>
            <a:r>
              <a:rPr lang="en-US" altLang="ja-JP" b="0" i="0" dirty="0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 &lt; 0.0001 are shown.</a:t>
            </a:r>
            <a:endParaRPr lang="en-US" altLang="ja-JP" dirty="0">
              <a:solidFill>
                <a:srgbClr val="222222"/>
              </a:solidFill>
              <a:latin typeface="Arial" panose="020B0604020202020204" pitchFamily="34" charset="0"/>
            </a:endParaRPr>
          </a:p>
          <a:p>
            <a:r>
              <a:rPr lang="en-US" altLang="ja-JP" b="0" i="0" dirty="0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 Data are expressed as the mean ± S.D.</a:t>
            </a:r>
            <a:endParaRPr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16907664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オブジェクト 3">
            <a:extLst>
              <a:ext uri="{FF2B5EF4-FFF2-40B4-BE49-F238E27FC236}">
                <a16:creationId xmlns:a16="http://schemas.microsoft.com/office/drawing/2014/main" id="{6DA60DBC-C56B-9331-2BEB-8CA3DE980AE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69149392"/>
              </p:ext>
            </p:extLst>
          </p:nvPr>
        </p:nvGraphicFramePr>
        <p:xfrm>
          <a:off x="1497780" y="0"/>
          <a:ext cx="3500286" cy="638386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1972823" imgH="3598671" progId="Prism9.Document">
                  <p:embed/>
                </p:oleObj>
              </mc:Choice>
              <mc:Fallback>
                <p:oleObj name="Prism 9" r:id="rId2" imgW="1972823" imgH="3598671" progId="Prism9.Document">
                  <p:embed/>
                  <p:pic>
                    <p:nvPicPr>
                      <p:cNvPr id="4" name="オブジェクト 3">
                        <a:extLst>
                          <a:ext uri="{FF2B5EF4-FFF2-40B4-BE49-F238E27FC236}">
                            <a16:creationId xmlns:a16="http://schemas.microsoft.com/office/drawing/2014/main" id="{6DA60DBC-C56B-9331-2BEB-8CA3DE980AE5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497780" y="0"/>
                        <a:ext cx="3500286" cy="638386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オブジェクト 4">
            <a:extLst>
              <a:ext uri="{FF2B5EF4-FFF2-40B4-BE49-F238E27FC236}">
                <a16:creationId xmlns:a16="http://schemas.microsoft.com/office/drawing/2014/main" id="{2FB4BE2B-955B-CFBC-0CC4-7A5A1979C6A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281314767"/>
              </p:ext>
            </p:extLst>
          </p:nvPr>
        </p:nvGraphicFramePr>
        <p:xfrm>
          <a:off x="6557964" y="0"/>
          <a:ext cx="3500286" cy="602445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4" imgW="2021442" imgH="3478055" progId="Prism9.Document">
                  <p:embed/>
                </p:oleObj>
              </mc:Choice>
              <mc:Fallback>
                <p:oleObj name="Prism 9" r:id="rId4" imgW="2021442" imgH="3478055" progId="Prism9.Document">
                  <p:embed/>
                  <p:pic>
                    <p:nvPicPr>
                      <p:cNvPr id="5" name="オブジェクト 4">
                        <a:extLst>
                          <a:ext uri="{FF2B5EF4-FFF2-40B4-BE49-F238E27FC236}">
                            <a16:creationId xmlns:a16="http://schemas.microsoft.com/office/drawing/2014/main" id="{2FB4BE2B-955B-CFBC-0CC4-7A5A1979C6A2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6557964" y="0"/>
                        <a:ext cx="3500286" cy="602445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D626A0C2-6FFC-36AD-C64D-31D159A65843}"/>
              </a:ext>
            </a:extLst>
          </p:cNvPr>
          <p:cNvSpPr txBox="1"/>
          <p:nvPr/>
        </p:nvSpPr>
        <p:spPr>
          <a:xfrm>
            <a:off x="2218267" y="6211669"/>
            <a:ext cx="9059333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dirty="0">
                <a:solidFill>
                  <a:srgbClr val="222222"/>
                </a:solidFill>
                <a:latin typeface="Arial" panose="020B0604020202020204" pitchFamily="34" charset="0"/>
              </a:rPr>
              <a:t>ns</a:t>
            </a:r>
            <a:r>
              <a:rPr lang="en-US" altLang="ja-JP" b="0" i="0" dirty="0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 </a:t>
            </a:r>
            <a:r>
              <a:rPr lang="en-US" altLang="ja-JP" b="0" i="1" dirty="0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p</a:t>
            </a:r>
            <a:r>
              <a:rPr lang="en-US" altLang="ja-JP" b="0" i="0" dirty="0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 </a:t>
            </a:r>
            <a:r>
              <a:rPr lang="ja-JP" altLang="en-US" b="0" i="0" dirty="0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≧</a:t>
            </a:r>
            <a:r>
              <a:rPr lang="en-US" altLang="ja-JP" b="0" i="0" dirty="0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 0.05, * </a:t>
            </a:r>
            <a:r>
              <a:rPr lang="en-US" altLang="ja-JP" b="0" i="1" dirty="0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p</a:t>
            </a:r>
            <a:r>
              <a:rPr lang="en-US" altLang="ja-JP" b="0" i="0" dirty="0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 &lt; 0.05, ** </a:t>
            </a:r>
            <a:r>
              <a:rPr lang="en-US" altLang="ja-JP" b="0" i="1" dirty="0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p</a:t>
            </a:r>
            <a:r>
              <a:rPr lang="en-US" altLang="ja-JP" b="0" i="0" dirty="0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 &lt; 0.01, *** </a:t>
            </a:r>
            <a:r>
              <a:rPr lang="en-US" altLang="ja-JP" b="0" i="1" dirty="0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p</a:t>
            </a:r>
            <a:r>
              <a:rPr lang="en-US" altLang="ja-JP" b="0" i="0" dirty="0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 &lt; 0.001, **** </a:t>
            </a:r>
            <a:r>
              <a:rPr lang="en-US" altLang="ja-JP" b="0" i="1" dirty="0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p</a:t>
            </a:r>
            <a:r>
              <a:rPr lang="en-US" altLang="ja-JP" b="0" i="0" dirty="0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 &lt; 0.0001 are shown.</a:t>
            </a:r>
            <a:endParaRPr lang="en-US" altLang="ja-JP" dirty="0">
              <a:solidFill>
                <a:srgbClr val="222222"/>
              </a:solidFill>
              <a:latin typeface="Arial" panose="020B0604020202020204" pitchFamily="34" charset="0"/>
            </a:endParaRPr>
          </a:p>
          <a:p>
            <a:r>
              <a:rPr lang="en-US" altLang="ja-JP" b="0" i="0" dirty="0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 Data are expressed as the mean ± S.D.</a:t>
            </a:r>
            <a:endParaRPr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38865447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オブジェクト 3">
            <a:extLst>
              <a:ext uri="{FF2B5EF4-FFF2-40B4-BE49-F238E27FC236}">
                <a16:creationId xmlns:a16="http://schemas.microsoft.com/office/drawing/2014/main" id="{CB5C6153-678D-F043-DC48-84BBDA365A2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88473652"/>
              </p:ext>
            </p:extLst>
          </p:nvPr>
        </p:nvGraphicFramePr>
        <p:xfrm>
          <a:off x="3999441" y="0"/>
          <a:ext cx="4193117" cy="594665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2425514" imgH="3440250" progId="Prism9.Document">
                  <p:embed/>
                </p:oleObj>
              </mc:Choice>
              <mc:Fallback>
                <p:oleObj name="Prism 9" r:id="rId2" imgW="2425514" imgH="3440250" progId="Prism9.Document">
                  <p:embed/>
                  <p:pic>
                    <p:nvPicPr>
                      <p:cNvPr id="4" name="オブジェクト 3">
                        <a:extLst>
                          <a:ext uri="{FF2B5EF4-FFF2-40B4-BE49-F238E27FC236}">
                            <a16:creationId xmlns:a16="http://schemas.microsoft.com/office/drawing/2014/main" id="{CB5C6153-678D-F043-DC48-84BBDA365A24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3999441" y="0"/>
                        <a:ext cx="4193117" cy="594665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AECC1755-FDB8-C2D5-8CAB-362C44245C53}"/>
              </a:ext>
            </a:extLst>
          </p:cNvPr>
          <p:cNvSpPr txBox="1"/>
          <p:nvPr/>
        </p:nvSpPr>
        <p:spPr>
          <a:xfrm>
            <a:off x="2167467" y="6017439"/>
            <a:ext cx="9059333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dirty="0">
                <a:solidFill>
                  <a:srgbClr val="222222"/>
                </a:solidFill>
                <a:latin typeface="Arial" panose="020B0604020202020204" pitchFamily="34" charset="0"/>
              </a:rPr>
              <a:t>ns</a:t>
            </a:r>
            <a:r>
              <a:rPr lang="en-US" altLang="ja-JP" b="0" i="0" dirty="0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 </a:t>
            </a:r>
            <a:r>
              <a:rPr lang="en-US" altLang="ja-JP" b="0" i="1" dirty="0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p</a:t>
            </a:r>
            <a:r>
              <a:rPr lang="en-US" altLang="ja-JP" b="0" i="0" dirty="0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 </a:t>
            </a:r>
            <a:r>
              <a:rPr lang="ja-JP" altLang="en-US" b="0" i="0" dirty="0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≧</a:t>
            </a:r>
            <a:r>
              <a:rPr lang="en-US" altLang="ja-JP" b="0" i="0" dirty="0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 0.05, * </a:t>
            </a:r>
            <a:r>
              <a:rPr lang="en-US" altLang="ja-JP" b="0" i="1" dirty="0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p</a:t>
            </a:r>
            <a:r>
              <a:rPr lang="en-US" altLang="ja-JP" b="0" i="0" dirty="0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 &lt; 0.05, ** </a:t>
            </a:r>
            <a:r>
              <a:rPr lang="en-US" altLang="ja-JP" b="0" i="1" dirty="0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p</a:t>
            </a:r>
            <a:r>
              <a:rPr lang="en-US" altLang="ja-JP" b="0" i="0" dirty="0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 &lt; 0.01, *** </a:t>
            </a:r>
            <a:r>
              <a:rPr lang="en-US" altLang="ja-JP" b="0" i="1" dirty="0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p</a:t>
            </a:r>
            <a:r>
              <a:rPr lang="en-US" altLang="ja-JP" b="0" i="0" dirty="0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 &lt; 0.001, **** </a:t>
            </a:r>
            <a:r>
              <a:rPr lang="en-US" altLang="ja-JP" b="0" i="1" dirty="0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p</a:t>
            </a:r>
            <a:r>
              <a:rPr lang="en-US" altLang="ja-JP" b="0" i="0" dirty="0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 &lt; 0.0001 are shown.</a:t>
            </a:r>
            <a:endParaRPr lang="en-US" altLang="ja-JP" dirty="0">
              <a:solidFill>
                <a:srgbClr val="222222"/>
              </a:solidFill>
              <a:latin typeface="Arial" panose="020B0604020202020204" pitchFamily="34" charset="0"/>
            </a:endParaRPr>
          </a:p>
          <a:p>
            <a:r>
              <a:rPr lang="en-US" altLang="ja-JP" b="0" i="0" dirty="0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 Data are expressed as the mean ± S.D.</a:t>
            </a:r>
            <a:endParaRPr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19714416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オブジェクト 3">
            <a:extLst>
              <a:ext uri="{FF2B5EF4-FFF2-40B4-BE49-F238E27FC236}">
                <a16:creationId xmlns:a16="http://schemas.microsoft.com/office/drawing/2014/main" id="{DD9BDB3D-23E4-ED29-4CE6-08F34EB40D7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22929391"/>
              </p:ext>
            </p:extLst>
          </p:nvPr>
        </p:nvGraphicFramePr>
        <p:xfrm>
          <a:off x="1252008" y="125769"/>
          <a:ext cx="4362946" cy="55325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2611704" imgH="3312074" progId="Prism9.Document">
                  <p:embed/>
                </p:oleObj>
              </mc:Choice>
              <mc:Fallback>
                <p:oleObj name="Prism 9" r:id="rId2" imgW="2611704" imgH="3312074" progId="Prism9.Document">
                  <p:embed/>
                  <p:pic>
                    <p:nvPicPr>
                      <p:cNvPr id="4" name="オブジェクト 3">
                        <a:extLst>
                          <a:ext uri="{FF2B5EF4-FFF2-40B4-BE49-F238E27FC236}">
                            <a16:creationId xmlns:a16="http://schemas.microsoft.com/office/drawing/2014/main" id="{DD9BDB3D-23E4-ED29-4CE6-08F34EB40D73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252008" y="125769"/>
                        <a:ext cx="4362946" cy="55325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オブジェクト 4">
            <a:extLst>
              <a:ext uri="{FF2B5EF4-FFF2-40B4-BE49-F238E27FC236}">
                <a16:creationId xmlns:a16="http://schemas.microsoft.com/office/drawing/2014/main" id="{8A44F892-6F7A-18D4-ED15-9EA3EEE9C4F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33862455"/>
              </p:ext>
            </p:extLst>
          </p:nvPr>
        </p:nvGraphicFramePr>
        <p:xfrm>
          <a:off x="6790268" y="125768"/>
          <a:ext cx="4149724" cy="538824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4" imgW="2472692" imgH="3211620" progId="Prism9.Document">
                  <p:embed/>
                </p:oleObj>
              </mc:Choice>
              <mc:Fallback>
                <p:oleObj name="Prism 9" r:id="rId4" imgW="2472692" imgH="3211620" progId="Prism9.Document">
                  <p:embed/>
                  <p:pic>
                    <p:nvPicPr>
                      <p:cNvPr id="5" name="オブジェクト 4">
                        <a:extLst>
                          <a:ext uri="{FF2B5EF4-FFF2-40B4-BE49-F238E27FC236}">
                            <a16:creationId xmlns:a16="http://schemas.microsoft.com/office/drawing/2014/main" id="{8A44F892-6F7A-18D4-ED15-9EA3EEE9C4F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6790268" y="125768"/>
                        <a:ext cx="4149724" cy="538824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65E15C81-D9C9-D28B-E3A8-7641012A1585}"/>
              </a:ext>
            </a:extLst>
          </p:cNvPr>
          <p:cNvSpPr txBox="1"/>
          <p:nvPr/>
        </p:nvSpPr>
        <p:spPr>
          <a:xfrm>
            <a:off x="2167467" y="6017439"/>
            <a:ext cx="9059333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dirty="0">
                <a:solidFill>
                  <a:srgbClr val="222222"/>
                </a:solidFill>
                <a:latin typeface="Arial" panose="020B0604020202020204" pitchFamily="34" charset="0"/>
              </a:rPr>
              <a:t>ns</a:t>
            </a:r>
            <a:r>
              <a:rPr lang="en-US" altLang="ja-JP" b="0" i="0" dirty="0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 </a:t>
            </a:r>
            <a:r>
              <a:rPr lang="en-US" altLang="ja-JP" b="0" i="1" dirty="0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p</a:t>
            </a:r>
            <a:r>
              <a:rPr lang="en-US" altLang="ja-JP" b="0" i="0" dirty="0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 </a:t>
            </a:r>
            <a:r>
              <a:rPr lang="ja-JP" altLang="en-US" b="0" i="0" dirty="0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≧</a:t>
            </a:r>
            <a:r>
              <a:rPr lang="en-US" altLang="ja-JP" b="0" i="0" dirty="0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 0.05, * </a:t>
            </a:r>
            <a:r>
              <a:rPr lang="en-US" altLang="ja-JP" b="0" i="1" dirty="0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p</a:t>
            </a:r>
            <a:r>
              <a:rPr lang="en-US" altLang="ja-JP" b="0" i="0" dirty="0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 &lt; 0.05, ** </a:t>
            </a:r>
            <a:r>
              <a:rPr lang="en-US" altLang="ja-JP" b="0" i="1" dirty="0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p</a:t>
            </a:r>
            <a:r>
              <a:rPr lang="en-US" altLang="ja-JP" b="0" i="0" dirty="0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 &lt; 0.01, *** </a:t>
            </a:r>
            <a:r>
              <a:rPr lang="en-US" altLang="ja-JP" b="0" i="1" dirty="0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p</a:t>
            </a:r>
            <a:r>
              <a:rPr lang="en-US" altLang="ja-JP" b="0" i="0" dirty="0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 &lt; 0.001, **** </a:t>
            </a:r>
            <a:r>
              <a:rPr lang="en-US" altLang="ja-JP" b="0" i="1" dirty="0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p</a:t>
            </a:r>
            <a:r>
              <a:rPr lang="en-US" altLang="ja-JP" b="0" i="0" dirty="0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 &lt; 0.0001 are shown.</a:t>
            </a:r>
            <a:endParaRPr lang="en-US" altLang="ja-JP" dirty="0">
              <a:solidFill>
                <a:srgbClr val="222222"/>
              </a:solidFill>
              <a:latin typeface="Arial" panose="020B0604020202020204" pitchFamily="34" charset="0"/>
            </a:endParaRPr>
          </a:p>
          <a:p>
            <a:r>
              <a:rPr lang="en-US" altLang="ja-JP" b="0" i="0" dirty="0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 Data are expressed as the mean ± S.D.</a:t>
            </a:r>
            <a:endParaRPr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85792403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オブジェクト 4">
            <a:extLst>
              <a:ext uri="{FF2B5EF4-FFF2-40B4-BE49-F238E27FC236}">
                <a16:creationId xmlns:a16="http://schemas.microsoft.com/office/drawing/2014/main" id="{EB9B4603-ED50-FFC6-1759-1EDEC2812AD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86526391"/>
              </p:ext>
            </p:extLst>
          </p:nvPr>
        </p:nvGraphicFramePr>
        <p:xfrm>
          <a:off x="2512219" y="1356782"/>
          <a:ext cx="3484563" cy="34702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3485033" imgH="3470494" progId="Prism9.Document">
                  <p:embed/>
                </p:oleObj>
              </mc:Choice>
              <mc:Fallback>
                <p:oleObj name="Prism 9" r:id="rId2" imgW="3485033" imgH="3470494" progId="Prism9.Document">
                  <p:embed/>
                  <p:pic>
                    <p:nvPicPr>
                      <p:cNvPr id="5" name="オブジェクト 4">
                        <a:extLst>
                          <a:ext uri="{FF2B5EF4-FFF2-40B4-BE49-F238E27FC236}">
                            <a16:creationId xmlns:a16="http://schemas.microsoft.com/office/drawing/2014/main" id="{EB9B4603-ED50-FFC6-1759-1EDEC2812AD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2512219" y="1356782"/>
                        <a:ext cx="3484563" cy="34702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オブジェクト 5">
            <a:extLst>
              <a:ext uri="{FF2B5EF4-FFF2-40B4-BE49-F238E27FC236}">
                <a16:creationId xmlns:a16="http://schemas.microsoft.com/office/drawing/2014/main" id="{A646CE96-BEE7-B8BB-C6BD-578D0587D10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45827938"/>
              </p:ext>
            </p:extLst>
          </p:nvPr>
        </p:nvGraphicFramePr>
        <p:xfrm>
          <a:off x="-57944" y="1386389"/>
          <a:ext cx="2570163" cy="34575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4" imgW="2570289" imgH="3458253" progId="Prism9.Document">
                  <p:embed/>
                </p:oleObj>
              </mc:Choice>
              <mc:Fallback>
                <p:oleObj name="Prism 9" r:id="rId4" imgW="2570289" imgH="3458253" progId="Prism9.Document">
                  <p:embed/>
                  <p:pic>
                    <p:nvPicPr>
                      <p:cNvPr id="6" name="オブジェクト 5">
                        <a:extLst>
                          <a:ext uri="{FF2B5EF4-FFF2-40B4-BE49-F238E27FC236}">
                            <a16:creationId xmlns:a16="http://schemas.microsoft.com/office/drawing/2014/main" id="{A646CE96-BEE7-B8BB-C6BD-578D0587D10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-57944" y="1386389"/>
                        <a:ext cx="2570163" cy="34575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オブジェクト 6">
            <a:extLst>
              <a:ext uri="{FF2B5EF4-FFF2-40B4-BE49-F238E27FC236}">
                <a16:creationId xmlns:a16="http://schemas.microsoft.com/office/drawing/2014/main" id="{6AFFAD47-2B9E-3445-A4A6-C504D1A15A1D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20297699"/>
              </p:ext>
            </p:extLst>
          </p:nvPr>
        </p:nvGraphicFramePr>
        <p:xfrm>
          <a:off x="6195220" y="1364476"/>
          <a:ext cx="2828925" cy="33496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6" imgW="2829586" imgH="3350239" progId="Prism9.Document">
                  <p:embed/>
                </p:oleObj>
              </mc:Choice>
              <mc:Fallback>
                <p:oleObj name="Prism 9" r:id="rId6" imgW="2829586" imgH="3350239" progId="Prism9.Document">
                  <p:embed/>
                  <p:pic>
                    <p:nvPicPr>
                      <p:cNvPr id="7" name="オブジェクト 6">
                        <a:extLst>
                          <a:ext uri="{FF2B5EF4-FFF2-40B4-BE49-F238E27FC236}">
                            <a16:creationId xmlns:a16="http://schemas.microsoft.com/office/drawing/2014/main" id="{6AFFAD47-2B9E-3445-A4A6-C504D1A15A1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6195220" y="1364476"/>
                        <a:ext cx="2828925" cy="33496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オブジェクト 7">
            <a:extLst>
              <a:ext uri="{FF2B5EF4-FFF2-40B4-BE49-F238E27FC236}">
                <a16:creationId xmlns:a16="http://schemas.microsoft.com/office/drawing/2014/main" id="{08EB6301-6F1C-3848-6EA5-00A9E286F57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88209146"/>
              </p:ext>
            </p:extLst>
          </p:nvPr>
        </p:nvGraphicFramePr>
        <p:xfrm>
          <a:off x="9302484" y="1413688"/>
          <a:ext cx="2752725" cy="33004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8" imgW="2753238" imgH="3299832" progId="Prism9.Document">
                  <p:embed/>
                </p:oleObj>
              </mc:Choice>
              <mc:Fallback>
                <p:oleObj name="Prism 9" r:id="rId8" imgW="2753238" imgH="3299832" progId="Prism9.Document">
                  <p:embed/>
                  <p:pic>
                    <p:nvPicPr>
                      <p:cNvPr id="8" name="オブジェクト 7">
                        <a:extLst>
                          <a:ext uri="{FF2B5EF4-FFF2-40B4-BE49-F238E27FC236}">
                            <a16:creationId xmlns:a16="http://schemas.microsoft.com/office/drawing/2014/main" id="{08EB6301-6F1C-3848-6EA5-00A9E286F57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9302484" y="1413688"/>
                        <a:ext cx="2752725" cy="330041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9" name="テキスト ボックス 8">
            <a:extLst>
              <a:ext uri="{FF2B5EF4-FFF2-40B4-BE49-F238E27FC236}">
                <a16:creationId xmlns:a16="http://schemas.microsoft.com/office/drawing/2014/main" id="{6A6DB9C3-5DB9-15C5-58E6-985C771EA638}"/>
              </a:ext>
            </a:extLst>
          </p:cNvPr>
          <p:cNvSpPr txBox="1"/>
          <p:nvPr/>
        </p:nvSpPr>
        <p:spPr>
          <a:xfrm>
            <a:off x="2167467" y="6017439"/>
            <a:ext cx="9059333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dirty="0">
                <a:solidFill>
                  <a:srgbClr val="222222"/>
                </a:solidFill>
                <a:latin typeface="Arial" panose="020B0604020202020204" pitchFamily="34" charset="0"/>
              </a:rPr>
              <a:t>ns</a:t>
            </a:r>
            <a:r>
              <a:rPr lang="en-US" altLang="ja-JP" b="0" i="0" dirty="0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 </a:t>
            </a:r>
            <a:r>
              <a:rPr lang="en-US" altLang="ja-JP" b="0" i="1" dirty="0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p</a:t>
            </a:r>
            <a:r>
              <a:rPr lang="en-US" altLang="ja-JP" b="0" i="0" dirty="0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 </a:t>
            </a:r>
            <a:r>
              <a:rPr lang="ja-JP" altLang="en-US" b="0" i="0" dirty="0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≧</a:t>
            </a:r>
            <a:r>
              <a:rPr lang="en-US" altLang="ja-JP" b="0" i="0" dirty="0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 0.05, * </a:t>
            </a:r>
            <a:r>
              <a:rPr lang="en-US" altLang="ja-JP" b="0" i="1" dirty="0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p</a:t>
            </a:r>
            <a:r>
              <a:rPr lang="en-US" altLang="ja-JP" b="0" i="0" dirty="0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 &lt; 0.05, ** </a:t>
            </a:r>
            <a:r>
              <a:rPr lang="en-US" altLang="ja-JP" b="0" i="1" dirty="0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p</a:t>
            </a:r>
            <a:r>
              <a:rPr lang="en-US" altLang="ja-JP" b="0" i="0" dirty="0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 &lt; 0.01, *** </a:t>
            </a:r>
            <a:r>
              <a:rPr lang="en-US" altLang="ja-JP" b="0" i="1" dirty="0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p</a:t>
            </a:r>
            <a:r>
              <a:rPr lang="en-US" altLang="ja-JP" b="0" i="0" dirty="0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 &lt; 0.001, **** </a:t>
            </a:r>
            <a:r>
              <a:rPr lang="en-US" altLang="ja-JP" b="0" i="1" dirty="0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p</a:t>
            </a:r>
            <a:r>
              <a:rPr lang="en-US" altLang="ja-JP" b="0" i="0" dirty="0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 &lt; 0.0001 are shown.</a:t>
            </a:r>
            <a:endParaRPr lang="en-US" altLang="ja-JP" dirty="0">
              <a:solidFill>
                <a:srgbClr val="222222"/>
              </a:solidFill>
              <a:latin typeface="Arial" panose="020B0604020202020204" pitchFamily="34" charset="0"/>
            </a:endParaRPr>
          </a:p>
          <a:p>
            <a:r>
              <a:rPr lang="en-US" altLang="ja-JP" b="0" i="0" dirty="0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 Data are expressed as the mean ± S.D.</a:t>
            </a:r>
            <a:endParaRPr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80521509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オブジェクト 3">
            <a:extLst>
              <a:ext uri="{FF2B5EF4-FFF2-40B4-BE49-F238E27FC236}">
                <a16:creationId xmlns:a16="http://schemas.microsoft.com/office/drawing/2014/main" id="{953A75C6-8B03-CC7C-9694-919F20C83BA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8855569"/>
              </p:ext>
            </p:extLst>
          </p:nvPr>
        </p:nvGraphicFramePr>
        <p:xfrm>
          <a:off x="4398963" y="197643"/>
          <a:ext cx="3394074" cy="541072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Prism 9" r:id="rId2" imgW="2015319" imgH="3211620" progId="Prism9.Document">
                  <p:embed/>
                </p:oleObj>
              </mc:Choice>
              <mc:Fallback>
                <p:oleObj name="Prism 9" r:id="rId2" imgW="2015319" imgH="3211620" progId="Prism9.Document">
                  <p:embed/>
                  <p:pic>
                    <p:nvPicPr>
                      <p:cNvPr id="4" name="オブジェクト 3">
                        <a:extLst>
                          <a:ext uri="{FF2B5EF4-FFF2-40B4-BE49-F238E27FC236}">
                            <a16:creationId xmlns:a16="http://schemas.microsoft.com/office/drawing/2014/main" id="{953A75C6-8B03-CC7C-9694-919F20C83BA9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4398963" y="197643"/>
                        <a:ext cx="3394074" cy="541072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7E58B3BE-B772-76D4-B140-CFA854F87B70}"/>
              </a:ext>
            </a:extLst>
          </p:cNvPr>
          <p:cNvSpPr txBox="1"/>
          <p:nvPr/>
        </p:nvSpPr>
        <p:spPr>
          <a:xfrm>
            <a:off x="2167467" y="6017439"/>
            <a:ext cx="9059333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dirty="0">
                <a:solidFill>
                  <a:srgbClr val="222222"/>
                </a:solidFill>
                <a:latin typeface="Arial" panose="020B0604020202020204" pitchFamily="34" charset="0"/>
              </a:rPr>
              <a:t>ns</a:t>
            </a:r>
            <a:r>
              <a:rPr lang="en-US" altLang="ja-JP" b="0" i="0" dirty="0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 </a:t>
            </a:r>
            <a:r>
              <a:rPr lang="en-US" altLang="ja-JP" b="0" i="1" dirty="0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p</a:t>
            </a:r>
            <a:r>
              <a:rPr lang="en-US" altLang="ja-JP" b="0" i="0" dirty="0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 </a:t>
            </a:r>
            <a:r>
              <a:rPr lang="ja-JP" altLang="en-US" b="0" i="0" dirty="0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≧</a:t>
            </a:r>
            <a:r>
              <a:rPr lang="en-US" altLang="ja-JP" b="0" i="0" dirty="0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 0.05, * </a:t>
            </a:r>
            <a:r>
              <a:rPr lang="en-US" altLang="ja-JP" b="0" i="1" dirty="0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p</a:t>
            </a:r>
            <a:r>
              <a:rPr lang="en-US" altLang="ja-JP" b="0" i="0" dirty="0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 &lt; 0.05, ** </a:t>
            </a:r>
            <a:r>
              <a:rPr lang="en-US" altLang="ja-JP" b="0" i="1" dirty="0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p</a:t>
            </a:r>
            <a:r>
              <a:rPr lang="en-US" altLang="ja-JP" b="0" i="0" dirty="0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 &lt; 0.01, *** </a:t>
            </a:r>
            <a:r>
              <a:rPr lang="en-US" altLang="ja-JP" b="0" i="1" dirty="0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p</a:t>
            </a:r>
            <a:r>
              <a:rPr lang="en-US" altLang="ja-JP" b="0" i="0" dirty="0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 &lt; 0.001, **** </a:t>
            </a:r>
            <a:r>
              <a:rPr lang="en-US" altLang="ja-JP" b="0" i="1" dirty="0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p</a:t>
            </a:r>
            <a:r>
              <a:rPr lang="en-US" altLang="ja-JP" b="0" i="0" dirty="0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 &lt; 0.0001 are shown.</a:t>
            </a:r>
            <a:endParaRPr lang="en-US" altLang="ja-JP" dirty="0">
              <a:solidFill>
                <a:srgbClr val="222222"/>
              </a:solidFill>
              <a:latin typeface="Arial" panose="020B0604020202020204" pitchFamily="34" charset="0"/>
            </a:endParaRPr>
          </a:p>
          <a:p>
            <a:r>
              <a:rPr lang="en-US" altLang="ja-JP" b="0" i="0" dirty="0">
                <a:solidFill>
                  <a:srgbClr val="222222"/>
                </a:solidFill>
                <a:effectLst/>
                <a:latin typeface="Arial" panose="020B0604020202020204" pitchFamily="34" charset="0"/>
              </a:rPr>
              <a:t> Data are expressed as the mean ± S.D.</a:t>
            </a:r>
            <a:endParaRPr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65333115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8</TotalTime>
  <Words>252</Words>
  <Application>Microsoft Office PowerPoint</Application>
  <PresentationFormat>ワイド画面</PresentationFormat>
  <Paragraphs>14</Paragraphs>
  <Slides>6</Slides>
  <Notes>0</Notes>
  <HiddenSlides>0</HiddenSlides>
  <MMClips>0</MMClips>
  <ScaleCrop>false</ScaleCrop>
  <HeadingPairs>
    <vt:vector size="8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埋め込まれた OLE サーバー</vt:lpstr>
      </vt:variant>
      <vt:variant>
        <vt:i4>1</vt:i4>
      </vt:variant>
      <vt:variant>
        <vt:lpstr>スライド タイトル</vt:lpstr>
      </vt:variant>
      <vt:variant>
        <vt:i4>6</vt:i4>
      </vt:variant>
    </vt:vector>
  </HeadingPairs>
  <TitlesOfParts>
    <vt:vector size="11" baseType="lpstr">
      <vt:lpstr>游ゴシック</vt:lpstr>
      <vt:lpstr>游ゴシック Light</vt:lpstr>
      <vt:lpstr>Arial</vt:lpstr>
      <vt:lpstr>Office テーマ</vt:lpstr>
      <vt:lpstr>Prism 9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宏矩 北島</dc:creator>
  <cp:lastModifiedBy>宏矩 北島</cp:lastModifiedBy>
  <cp:revision>1</cp:revision>
  <dcterms:created xsi:type="dcterms:W3CDTF">2024-11-17T02:01:27Z</dcterms:created>
  <dcterms:modified xsi:type="dcterms:W3CDTF">2024-11-19T09:02:43Z</dcterms:modified>
</cp:coreProperties>
</file>